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5051A2-5279-4095-994F-37AB6F52E0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EC013-D673-45F7-B5F2-C0F5F2CB9A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BE42FF-F657-440F-968E-205FCAC639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1A023F-1E5A-4E0E-885D-573FC5E289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F72E6-DED4-4CFE-8C70-010D899DB1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27FFB1-1351-4D14-A361-E33C390DE8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264CD-E2DF-43A8-A9FE-98DB118992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0FA532-E86B-4D69-8E05-7B27279327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5BF6BC-7EFE-4AD4-9C35-F969CC0039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5E47EB-3B4A-4D03-8C82-CD03EB56A5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B458FD-4EE0-4B2B-A0C5-155DC0FB2F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5D5AF-E4EC-4225-84DF-D24D0C91E4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C5CC90-7358-4886-A61A-DC12F717AD4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04920" y="5356080"/>
            <a:ext cx="8229600" cy="11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7000"/>
          </a:bodyPr>
          <a:p>
            <a:pPr marL="332640" indent="-332640" algn="just"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3. Correlation between microarray and qRT-PCR data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Correlation between array and qRT-PCR data was highly statistically significant for downregulated genes (panel A), but not significant for upregulated genes (panel B). Data were fitted using a linear regression model, with p-value and correlation coefficient (r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) indicated for each fit. In panel A, absolute value of 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old change was plotted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4"/>
          <p:cNvGraphicFramePr/>
          <p:nvPr/>
        </p:nvGraphicFramePr>
        <p:xfrm>
          <a:off x="76320" y="703440"/>
          <a:ext cx="8931240" cy="4554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320" y="703440"/>
                    <a:ext cx="8931240" cy="4554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"/>
          <p:cNvSpPr/>
          <p:nvPr/>
        </p:nvSpPr>
        <p:spPr>
          <a:xfrm>
            <a:off x="294120" y="7984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789800" y="7984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19T18:59:31Z</dcterms:created>
  <dc:creator>Marta Margeta</dc:creator>
  <dc:description/>
  <dc:language>en-US</dc:language>
  <cp:lastModifiedBy>Marta Margeta</cp:lastModifiedBy>
  <dcterms:modified xsi:type="dcterms:W3CDTF">2010-06-24T23:43:05Z</dcterms:modified>
  <cp:revision>3</cp:revision>
  <dc:subject/>
  <dc:title>Slide 1</dc:title>
</cp:coreProperties>
</file>